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35763" cy="98679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F6A756-B786-42B3-9E1E-5E55CA1AF22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5B8BD4-5178-43D8-9DB9-5AA2C8EDCC8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3F4B1A-E843-4706-8B35-07CB199D8FC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107896-217B-4FE6-B6C8-7E936468A97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909A1E-C0C9-41E8-B45A-2DC4C5A8264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DE2276-C198-49EC-AF77-C975CC63C13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1482B9-CB95-4843-BCE3-89491F02141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FF2A5B-B809-4064-9A23-90013B87DCD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7B5AFD-BBAA-4303-9A73-758B9658FFE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94E10A-26DE-46C2-92FC-4011EB1A6D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F0EEFE-8B93-416F-BECB-0DCB2A4E347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A0656B-105B-4C1B-A5D7-CF01FFA1B52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B062A38-1E74-4718-A911-7E4B9B7F3455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8"/>
          <p:cNvSpPr/>
          <p:nvPr/>
        </p:nvSpPr>
        <p:spPr>
          <a:xfrm>
            <a:off x="4005360" y="7524720"/>
            <a:ext cx="2663640" cy="934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Fig. S2.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Comparison of pathways up- (red) and down-regulated (blue) by LKM512 administration and ageing (All pathways). |Z-score| more than 1.98 was considered significant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テキスト ボックス 3"/>
          <p:cNvSpPr/>
          <p:nvPr/>
        </p:nvSpPr>
        <p:spPr>
          <a:xfrm>
            <a:off x="3645000" y="826920"/>
            <a:ext cx="1439640" cy="945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athways up in LKM512 mic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ompared with control</a:t>
            </a: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ic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athways down in control mic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ompared with younger</a:t>
            </a: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ic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Picture 1038" descr=""/>
          <p:cNvPicPr/>
          <p:nvPr/>
        </p:nvPicPr>
        <p:blipFill>
          <a:blip r:embed="rId1"/>
          <a:stretch/>
        </p:blipFill>
        <p:spPr>
          <a:xfrm>
            <a:off x="428760" y="250920"/>
            <a:ext cx="3000240" cy="870732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1039" descr=""/>
          <p:cNvPicPr/>
          <p:nvPr/>
        </p:nvPicPr>
        <p:blipFill>
          <a:blip r:embed="rId2"/>
          <a:stretch/>
        </p:blipFill>
        <p:spPr>
          <a:xfrm>
            <a:off x="3478320" y="3214800"/>
            <a:ext cx="598320" cy="1071360"/>
          </a:xfrm>
          <a:prstGeom prst="rect">
            <a:avLst/>
          </a:prstGeom>
          <a:ln w="0">
            <a:noFill/>
          </a:ln>
        </p:spPr>
      </p:pic>
      <p:sp>
        <p:nvSpPr>
          <p:cNvPr id="45" name="右中かっこ 1042"/>
          <p:cNvSpPr/>
          <p:nvPr/>
        </p:nvSpPr>
        <p:spPr>
          <a:xfrm>
            <a:off x="3500280" y="539640"/>
            <a:ext cx="144720" cy="1440000"/>
          </a:xfrm>
          <a:custGeom>
            <a:avLst/>
            <a:gdLst>
              <a:gd name="textAreaLeft" fmla="*/ 0 w 144720"/>
              <a:gd name="textAreaRight" fmla="*/ 52200 w 144720"/>
              <a:gd name="textAreaTop" fmla="*/ 16560 h 1440000"/>
              <a:gd name="textAreaBottom" fmla="*/ 1423440 h 14400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400"/>
                  <a:pt x="10800" y="800"/>
                </a:cubicBezTo>
                <a:lnTo>
                  <a:pt x="10800" y="10000"/>
                </a:lnTo>
                <a:cubicBezTo>
                  <a:pt x="10800" y="10400"/>
                  <a:pt x="16200" y="10800"/>
                  <a:pt x="21600" y="10800"/>
                </a:cubicBezTo>
                <a:cubicBezTo>
                  <a:pt x="16200" y="10800"/>
                  <a:pt x="10800" y="11200"/>
                  <a:pt x="10800" y="11600"/>
                </a:cubicBezTo>
                <a:lnTo>
                  <a:pt x="10800" y="20800"/>
                </a:lnTo>
                <a:cubicBezTo>
                  <a:pt x="10800" y="212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右中かっこ 1043"/>
          <p:cNvSpPr/>
          <p:nvPr/>
        </p:nvSpPr>
        <p:spPr>
          <a:xfrm>
            <a:off x="3502080" y="5211720"/>
            <a:ext cx="142920" cy="3719520"/>
          </a:xfrm>
          <a:custGeom>
            <a:avLst/>
            <a:gdLst>
              <a:gd name="textAreaLeft" fmla="*/ 0 w 142920"/>
              <a:gd name="textAreaRight" fmla="*/ 51480 w 142920"/>
              <a:gd name="textAreaTop" fmla="*/ 16200 h 3719520"/>
              <a:gd name="textAreaBottom" fmla="*/ 3703320 h 37195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153"/>
                  <a:pt x="10800" y="306"/>
                </a:cubicBezTo>
                <a:lnTo>
                  <a:pt x="10800" y="6675"/>
                </a:lnTo>
                <a:cubicBezTo>
                  <a:pt x="10800" y="6828"/>
                  <a:pt x="16200" y="6981"/>
                  <a:pt x="21600" y="6981"/>
                </a:cubicBezTo>
                <a:cubicBezTo>
                  <a:pt x="16200" y="6981"/>
                  <a:pt x="10800" y="7134"/>
                  <a:pt x="10800" y="7287"/>
                </a:cubicBezTo>
                <a:lnTo>
                  <a:pt x="10800" y="21294"/>
                </a:lnTo>
                <a:cubicBezTo>
                  <a:pt x="10800" y="21447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テキスト ボックス 1044"/>
          <p:cNvSpPr/>
          <p:nvPr/>
        </p:nvSpPr>
        <p:spPr>
          <a:xfrm>
            <a:off x="3598920" y="5964120"/>
            <a:ext cx="151128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athways down in LKM512 mic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ompared with control</a:t>
            </a: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ic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athways up in control mic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ompared with younger</a:t>
            </a: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ic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81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2-07T13:57:50Z</dcterms:created>
  <dc:creator>Mitsuharu Matsumoto</dc:creator>
  <dc:description/>
  <dc:language>en-US</dc:language>
  <cp:lastModifiedBy>m.matumoto</cp:lastModifiedBy>
  <dcterms:modified xsi:type="dcterms:W3CDTF">2011-07-26T11:04:29Z</dcterms:modified>
  <cp:revision>255</cp:revision>
  <dc:subject/>
  <dc:title>スライド 1</dc:title>
</cp:coreProperties>
</file>